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107"/>
    <p:restoredTop sz="95958"/>
  </p:normalViewPr>
  <p:slideViewPr>
    <p:cSldViewPr snapToGrid="0" snapToObjects="1">
      <p:cViewPr varScale="1">
        <p:scale>
          <a:sx n="69" d="100"/>
          <a:sy n="69" d="100"/>
        </p:scale>
        <p:origin x="327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9364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29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8965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8653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1128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42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540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360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2144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238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149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F7701-5106-824A-8F2D-E05F1086CD33}" type="datetimeFigureOut">
              <a:rPr lang="en-US" smtClean="0"/>
              <a:t>1/7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67DE2-0A0D-C349-B2A2-F8BFC15EA2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9839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946DDF9-E03F-9644-9C0E-704CB2650144}"/>
              </a:ext>
            </a:extLst>
          </p:cNvPr>
          <p:cNvSpPr txBox="1"/>
          <p:nvPr/>
        </p:nvSpPr>
        <p:spPr>
          <a:xfrm>
            <a:off x="248121" y="1537855"/>
            <a:ext cx="2908168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5 LATE-STAGE ENDOMETRIOID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NDOMETRIAL TUMOR/NORMAL PAIR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E64E22-A163-DE4E-A1A3-FCAEB183E874}"/>
              </a:ext>
            </a:extLst>
          </p:cNvPr>
          <p:cNvSpPr txBox="1"/>
          <p:nvPr/>
        </p:nvSpPr>
        <p:spPr>
          <a:xfrm>
            <a:off x="248121" y="3241967"/>
            <a:ext cx="2127505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XOME SEQUENCING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Illumina HiSeq 2000 platform)</a:t>
            </a:r>
            <a:endParaRPr lang="en-US" sz="11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A10DBF-1AD7-B040-A2B6-465B4B788BEF}"/>
              </a:ext>
            </a:extLst>
          </p:cNvPr>
          <p:cNvSpPr txBox="1"/>
          <p:nvPr/>
        </p:nvSpPr>
        <p:spPr>
          <a:xfrm>
            <a:off x="248121" y="4490893"/>
            <a:ext cx="2900153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OMATIC VARIANT CALLING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Strelka, Shimmer, SomaticSniper, MuTect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53C5CE-F82C-7B44-8671-F977C0680A4C}"/>
              </a:ext>
            </a:extLst>
          </p:cNvPr>
          <p:cNvSpPr txBox="1"/>
          <p:nvPr/>
        </p:nvSpPr>
        <p:spPr>
          <a:xfrm>
            <a:off x="248121" y="3866430"/>
            <a:ext cx="2901756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EQUENCE READ ALIGNMENT TO hg19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NovoAlign version 2.08.02)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71D929-ECAA-6B4B-A2F5-2CBE76A4632C}"/>
              </a:ext>
            </a:extLst>
          </p:cNvPr>
          <p:cNvSpPr txBox="1"/>
          <p:nvPr/>
        </p:nvSpPr>
        <p:spPr>
          <a:xfrm>
            <a:off x="248121" y="6364282"/>
            <a:ext cx="5296680" cy="144655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OMATIC VARIANT FILTERING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tained variants with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minimum of 14 reads in the tumor and 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minimum of 8 reads in the match normal an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 overall frequency of less than 3% (of the 15) normal samples an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minor allele frequency of less than or equal to 5% in dbSNP Build 135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NVs called by all four algorithms (Strelka, Shimmer, SomaticSniper, MuTect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-dels called by either Strelka or Shimmer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D1FB37-AE32-F843-84CD-85C5C9EA0A26}"/>
              </a:ext>
            </a:extLst>
          </p:cNvPr>
          <p:cNvSpPr txBox="1"/>
          <p:nvPr/>
        </p:nvSpPr>
        <p:spPr>
          <a:xfrm>
            <a:off x="248121" y="5115356"/>
            <a:ext cx="3280065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ARSIFTER–FORMATTED FILE GENERATION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VarSifter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0549E34-2404-5941-B5CF-6192E69DCCE1}"/>
              </a:ext>
            </a:extLst>
          </p:cNvPr>
          <p:cNvSpPr txBox="1"/>
          <p:nvPr/>
        </p:nvSpPr>
        <p:spPr>
          <a:xfrm>
            <a:off x="248121" y="2617504"/>
            <a:ext cx="3515706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NA LIBRARY PREPARATION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SeqCap 114  EZ Exome + UTR capture kit (Roche)) </a:t>
            </a:r>
            <a:endParaRPr lang="en-US" sz="11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F0BE57-F486-E640-A02D-65901BCEADB8}"/>
              </a:ext>
            </a:extLst>
          </p:cNvPr>
          <p:cNvSpPr txBox="1"/>
          <p:nvPr/>
        </p:nvSpPr>
        <p:spPr>
          <a:xfrm>
            <a:off x="248121" y="2162318"/>
            <a:ext cx="3195105" cy="26161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ENOMIC DNA ISOLATION &amp; PURIFICA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42B83D-C5B8-1648-893A-946E726FDC42}"/>
              </a:ext>
            </a:extLst>
          </p:cNvPr>
          <p:cNvSpPr txBox="1"/>
          <p:nvPr/>
        </p:nvSpPr>
        <p:spPr>
          <a:xfrm>
            <a:off x="248121" y="5739819"/>
            <a:ext cx="2484976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OMATIC VARIANT ANNOTATION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NNOVAR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55772B-7DA6-F048-A560-940922B5AA2E}"/>
              </a:ext>
            </a:extLst>
          </p:cNvPr>
          <p:cNvSpPr txBox="1"/>
          <p:nvPr/>
        </p:nvSpPr>
        <p:spPr>
          <a:xfrm>
            <a:off x="248121" y="8004408"/>
            <a:ext cx="4668266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NOTATION OF RETAINED VARIANTS AGAINST GENCODE hg19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Oncotator (v1.5.3.0))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7AB253E-9106-704E-B429-09DC4D46D486}"/>
              </a:ext>
            </a:extLst>
          </p:cNvPr>
          <p:cNvSpPr txBox="1"/>
          <p:nvPr/>
        </p:nvSpPr>
        <p:spPr>
          <a:xfrm>
            <a:off x="248121" y="8628871"/>
            <a:ext cx="5025735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XCLUSION OF NONCODING VARIANTS WITH A VARIANT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LASSIFICATION OF UTR, Flank, lincRNA, RNA, Intron, or De novo start</a:t>
            </a:r>
          </a:p>
        </p:txBody>
      </p:sp>
      <p:sp>
        <p:nvSpPr>
          <p:cNvPr id="2" name="Down Arrow 1">
            <a:extLst>
              <a:ext uri="{FF2B5EF4-FFF2-40B4-BE49-F238E27FC236}">
                <a16:creationId xmlns:a16="http://schemas.microsoft.com/office/drawing/2014/main" id="{BFDFBB7D-16C6-9D47-BBEC-A9B4E92E6C01}"/>
              </a:ext>
            </a:extLst>
          </p:cNvPr>
          <p:cNvSpPr/>
          <p:nvPr/>
        </p:nvSpPr>
        <p:spPr>
          <a:xfrm>
            <a:off x="291117" y="1968742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Down Arrow 17">
            <a:extLst>
              <a:ext uri="{FF2B5EF4-FFF2-40B4-BE49-F238E27FC236}">
                <a16:creationId xmlns:a16="http://schemas.microsoft.com/office/drawing/2014/main" id="{46AEA4C1-D624-2D4C-B9CB-BAAF8323506C}"/>
              </a:ext>
            </a:extLst>
          </p:cNvPr>
          <p:cNvSpPr/>
          <p:nvPr/>
        </p:nvSpPr>
        <p:spPr>
          <a:xfrm>
            <a:off x="291117" y="2425942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Down Arrow 18">
            <a:extLst>
              <a:ext uri="{FF2B5EF4-FFF2-40B4-BE49-F238E27FC236}">
                <a16:creationId xmlns:a16="http://schemas.microsoft.com/office/drawing/2014/main" id="{D2C3DF47-AC71-AB46-9DDF-651FE2252460}"/>
              </a:ext>
            </a:extLst>
          </p:cNvPr>
          <p:cNvSpPr/>
          <p:nvPr/>
        </p:nvSpPr>
        <p:spPr>
          <a:xfrm>
            <a:off x="291117" y="3047328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Down Arrow 19">
            <a:extLst>
              <a:ext uri="{FF2B5EF4-FFF2-40B4-BE49-F238E27FC236}">
                <a16:creationId xmlns:a16="http://schemas.microsoft.com/office/drawing/2014/main" id="{8519EF3F-2D5F-E244-BB4D-9BFBD3B9633D}"/>
              </a:ext>
            </a:extLst>
          </p:cNvPr>
          <p:cNvSpPr/>
          <p:nvPr/>
        </p:nvSpPr>
        <p:spPr>
          <a:xfrm>
            <a:off x="291117" y="3675471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Down Arrow 20">
            <a:extLst>
              <a:ext uri="{FF2B5EF4-FFF2-40B4-BE49-F238E27FC236}">
                <a16:creationId xmlns:a16="http://schemas.microsoft.com/office/drawing/2014/main" id="{BA1EA637-EB69-ED49-8422-58363FBADA30}"/>
              </a:ext>
            </a:extLst>
          </p:cNvPr>
          <p:cNvSpPr/>
          <p:nvPr/>
        </p:nvSpPr>
        <p:spPr>
          <a:xfrm>
            <a:off x="291117" y="4299211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Down Arrow 21">
            <a:extLst>
              <a:ext uri="{FF2B5EF4-FFF2-40B4-BE49-F238E27FC236}">
                <a16:creationId xmlns:a16="http://schemas.microsoft.com/office/drawing/2014/main" id="{51A2FE0E-CAF9-AF40-9804-AEDDA3E007F3}"/>
              </a:ext>
            </a:extLst>
          </p:cNvPr>
          <p:cNvSpPr/>
          <p:nvPr/>
        </p:nvSpPr>
        <p:spPr>
          <a:xfrm>
            <a:off x="291117" y="4922953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Down Arrow 22">
            <a:extLst>
              <a:ext uri="{FF2B5EF4-FFF2-40B4-BE49-F238E27FC236}">
                <a16:creationId xmlns:a16="http://schemas.microsoft.com/office/drawing/2014/main" id="{E3D6F043-C020-2441-B6F7-6972069ECD4E}"/>
              </a:ext>
            </a:extLst>
          </p:cNvPr>
          <p:cNvSpPr/>
          <p:nvPr/>
        </p:nvSpPr>
        <p:spPr>
          <a:xfrm>
            <a:off x="291117" y="5546694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Down Arrow 23">
            <a:extLst>
              <a:ext uri="{FF2B5EF4-FFF2-40B4-BE49-F238E27FC236}">
                <a16:creationId xmlns:a16="http://schemas.microsoft.com/office/drawing/2014/main" id="{604511A8-2C7C-9642-9062-DF10E38F8C5B}"/>
              </a:ext>
            </a:extLst>
          </p:cNvPr>
          <p:cNvSpPr/>
          <p:nvPr/>
        </p:nvSpPr>
        <p:spPr>
          <a:xfrm>
            <a:off x="291117" y="6161008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Down Arrow 24">
            <a:extLst>
              <a:ext uri="{FF2B5EF4-FFF2-40B4-BE49-F238E27FC236}">
                <a16:creationId xmlns:a16="http://schemas.microsoft.com/office/drawing/2014/main" id="{D076C42A-CF66-CA4A-8489-43E800A5BF9D}"/>
              </a:ext>
            </a:extLst>
          </p:cNvPr>
          <p:cNvSpPr/>
          <p:nvPr/>
        </p:nvSpPr>
        <p:spPr>
          <a:xfrm>
            <a:off x="291117" y="7812268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Down Arrow 25">
            <a:extLst>
              <a:ext uri="{FF2B5EF4-FFF2-40B4-BE49-F238E27FC236}">
                <a16:creationId xmlns:a16="http://schemas.microsoft.com/office/drawing/2014/main" id="{5B1579E3-B190-B24D-A20C-C699A8B3F11F}"/>
              </a:ext>
            </a:extLst>
          </p:cNvPr>
          <p:cNvSpPr/>
          <p:nvPr/>
        </p:nvSpPr>
        <p:spPr>
          <a:xfrm>
            <a:off x="291117" y="8445437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Down Arrow 26">
            <a:extLst>
              <a:ext uri="{FF2B5EF4-FFF2-40B4-BE49-F238E27FC236}">
                <a16:creationId xmlns:a16="http://schemas.microsoft.com/office/drawing/2014/main" id="{4196869A-C386-884A-9565-4D484FCA0A6E}"/>
              </a:ext>
            </a:extLst>
          </p:cNvPr>
          <p:cNvSpPr/>
          <p:nvPr/>
        </p:nvSpPr>
        <p:spPr>
          <a:xfrm>
            <a:off x="291117" y="9059751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2BDE137-6C1B-FC4A-846E-7331F0EE8C05}"/>
              </a:ext>
            </a:extLst>
          </p:cNvPr>
          <p:cNvSpPr txBox="1"/>
          <p:nvPr/>
        </p:nvSpPr>
        <p:spPr>
          <a:xfrm>
            <a:off x="3981515" y="2630078"/>
            <a:ext cx="2755883" cy="43088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ICROSATELLITE INSTABILITY (MSI)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ESTIN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Promega kit)</a:t>
            </a:r>
          </a:p>
        </p:txBody>
      </p:sp>
      <p:sp>
        <p:nvSpPr>
          <p:cNvPr id="28" name="Down Arrow 27">
            <a:extLst>
              <a:ext uri="{FF2B5EF4-FFF2-40B4-BE49-F238E27FC236}">
                <a16:creationId xmlns:a16="http://schemas.microsoft.com/office/drawing/2014/main" id="{63A419A9-5863-554F-86D9-4DD7C5075804}"/>
              </a:ext>
            </a:extLst>
          </p:cNvPr>
          <p:cNvSpPr/>
          <p:nvPr/>
        </p:nvSpPr>
        <p:spPr>
          <a:xfrm>
            <a:off x="4026163" y="2243492"/>
            <a:ext cx="183623" cy="3710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98B0193F-2A59-664D-96D3-E6AAC163CA85}"/>
              </a:ext>
            </a:extLst>
          </p:cNvPr>
          <p:cNvSpPr/>
          <p:nvPr/>
        </p:nvSpPr>
        <p:spPr>
          <a:xfrm>
            <a:off x="3445259" y="2243041"/>
            <a:ext cx="690465" cy="8389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9B2C8EA-6542-8048-9815-48CEFF74FE8D}"/>
              </a:ext>
            </a:extLst>
          </p:cNvPr>
          <p:cNvSpPr txBox="1"/>
          <p:nvPr/>
        </p:nvSpPr>
        <p:spPr>
          <a:xfrm>
            <a:off x="205275" y="1119674"/>
            <a:ext cx="1387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HGRI COHOR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E39D1B2-754B-9540-A097-ED74776B8310}"/>
              </a:ext>
            </a:extLst>
          </p:cNvPr>
          <p:cNvSpPr txBox="1"/>
          <p:nvPr/>
        </p:nvSpPr>
        <p:spPr>
          <a:xfrm>
            <a:off x="248121" y="9254927"/>
            <a:ext cx="3047629" cy="76944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SSIGN STATISTICAL SIGNIFICANCE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p-VALUES &amp; q-VALUES) TO MUTATED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ENES WITHIN 66 LATE-STAGE TUMORS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MutSigCV (v1.4)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377CF3A-C727-5842-9B51-F9C065E08CA9}"/>
              </a:ext>
            </a:extLst>
          </p:cNvPr>
          <p:cNvSpPr txBox="1"/>
          <p:nvPr/>
        </p:nvSpPr>
        <p:spPr>
          <a:xfrm>
            <a:off x="260821" y="10237435"/>
            <a:ext cx="5044971" cy="60016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NOTATE STATISTICALLY SIGNIFICANTLY MUTATED GENES (SMGS)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 LATE-STAGE TUMORS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Somatically mutated genes with a false discovery rate (q-value) ≤0.10)</a:t>
            </a:r>
          </a:p>
        </p:txBody>
      </p:sp>
      <p:sp>
        <p:nvSpPr>
          <p:cNvPr id="33" name="Down Arrow 32">
            <a:extLst>
              <a:ext uri="{FF2B5EF4-FFF2-40B4-BE49-F238E27FC236}">
                <a16:creationId xmlns:a16="http://schemas.microsoft.com/office/drawing/2014/main" id="{3E3B9BBC-6CEF-7D49-92D5-98C2E3871BAC}"/>
              </a:ext>
            </a:extLst>
          </p:cNvPr>
          <p:cNvSpPr/>
          <p:nvPr/>
        </p:nvSpPr>
        <p:spPr>
          <a:xfrm>
            <a:off x="316517" y="10031155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2189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0</TotalTime>
  <Words>245</Words>
  <Application>Microsoft Macintosh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Bell, Daphne (NIH/NHGRI) [E]</cp:lastModifiedBy>
  <cp:revision>56</cp:revision>
  <dcterms:created xsi:type="dcterms:W3CDTF">2021-08-26T17:03:55Z</dcterms:created>
  <dcterms:modified xsi:type="dcterms:W3CDTF">2022-01-07T17:47:26Z</dcterms:modified>
</cp:coreProperties>
</file>